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E294715-D8F6-4D39-B262-3AD812FC6A44}" v="1" dt="2025-11-21T17:28:30.31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55" autoAdjust="0"/>
    <p:restoredTop sz="94660"/>
  </p:normalViewPr>
  <p:slideViewPr>
    <p:cSldViewPr snapToGrid="0">
      <p:cViewPr varScale="1">
        <p:scale>
          <a:sx n="43" d="100"/>
          <a:sy n="43" d="100"/>
        </p:scale>
        <p:origin x="66" y="5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ghan Moran" userId="30256bc4-a161-4226-a2d6-4e8766bd09d0" providerId="ADAL" clId="{8B0668C6-C7D0-4AFB-9B8E-773148CE68EF}"/>
    <pc:docChg chg="addSld delSld modSld">
      <pc:chgData name="Meghan Moran" userId="30256bc4-a161-4226-a2d6-4e8766bd09d0" providerId="ADAL" clId="{8B0668C6-C7D0-4AFB-9B8E-773148CE68EF}" dt="2025-11-21T17:28:32.475" v="1" actId="47"/>
      <pc:docMkLst>
        <pc:docMk/>
      </pc:docMkLst>
      <pc:sldChg chg="del">
        <pc:chgData name="Meghan Moran" userId="30256bc4-a161-4226-a2d6-4e8766bd09d0" providerId="ADAL" clId="{8B0668C6-C7D0-4AFB-9B8E-773148CE68EF}" dt="2025-11-21T17:28:32.475" v="1" actId="47"/>
        <pc:sldMkLst>
          <pc:docMk/>
          <pc:sldMk cId="2129892698" sldId="272"/>
        </pc:sldMkLst>
      </pc:sldChg>
      <pc:sldChg chg="add">
        <pc:chgData name="Meghan Moran" userId="30256bc4-a161-4226-a2d6-4e8766bd09d0" providerId="ADAL" clId="{8B0668C6-C7D0-4AFB-9B8E-773148CE68EF}" dt="2025-11-21T17:28:30.301" v="0"/>
        <pc:sldMkLst>
          <pc:docMk/>
          <pc:sldMk cId="3779971660" sldId="374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DC337-203F-6ACA-81AC-A8CD27A5AE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9D7B5D-55B0-0F5B-6BA0-DC90372DD4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04F32-11AA-CBE5-2813-45379BA1F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299BDA-A4D5-5426-1C32-74827FEEF9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B5029E-681C-D8EA-A9CB-183241D8F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901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3EB47E-F2C1-413F-B074-279E0D348F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D872DB-08DE-46C0-9BE7-C9EA6F70CF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F2B9D5-E42C-8729-D31B-A4C4FFFC2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023C39-0265-A664-15E0-F0096A2F5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B05800-E7E3-DEA3-F080-8507E4D9C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546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4666AB-3A2A-CAEC-CCB0-2D71536B3C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E2294C-2D59-A5D6-2BB4-5F224E22D2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8C372F-A7A7-E7B0-F777-9CFD14855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BE6756-259C-5BDB-275F-725DCB4E8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152E30-8BB8-6455-1F33-5535A5DF3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901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7A5150-CAE5-4302-4470-A41AD735A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25F923-B478-8748-7F7D-2781A5F69C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D437E4-8C26-5284-E89D-FACD8C431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B7BBD2-44EF-10AD-EA54-166AB146C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019E2B-FA57-B58C-DA85-FACDE38D7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352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94D0AF-E17E-151C-EE82-E6F69A538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EE6578-DA8B-EE9A-84AE-827EC7379F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F4B51F-933B-BF26-83C2-3C0F127D0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3B3783-29CD-7E76-8B07-F52AFCF91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079BBE-A69E-4052-D46A-EFE735E63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462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678B95-B489-6691-A121-9CC6C4B712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C91E10-CD3D-3EDC-DFB0-803D967D56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333D40-635E-6ABB-1B03-872F3BE745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E6EE93-F983-49B8-E287-350ACD5A5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60D05B-83E8-E736-62CA-978BDAC89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93DB88-7FCA-805B-B25D-A15ED303A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058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82B4D2-B742-74AD-7E4F-1C36C8BF38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63AD43-55EA-D2A5-C714-0F0235245F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B4C5E5-8085-43E6-0982-479004178F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4259B2-C329-5225-AFC6-1C45D9A86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7D774B-43D2-0E6E-192B-05B59342A2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031BED-9BF2-1594-9AF9-A8C3F8574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4B5B88-637B-2382-48A0-432B9BCA7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96C8DB-709D-927A-830E-6AA222BC3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174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449D5E-0BC9-365E-FBD0-5C50E02B1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96A71A-9EAC-E539-A92E-A8C4A2D89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358E02-2118-7788-D756-0079827477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31ED9F-AC4C-29FD-4CB8-C8FF1F5E6D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472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886813-0D54-97B1-9E59-858D295EA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2F8018-E02D-A9CE-D719-36E85435A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90113A-1DA2-D8A0-5CA8-0ED75C829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972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43400C-96A9-3332-9F54-0E6371A59D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3E3DF7-C799-1095-64F8-E94B03841B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4E82F2-DA81-4ABB-2630-6746143C0F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19D5D2-2449-89D1-2373-E4AF24D1C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9B6FAA-D7A8-C85A-18DA-83379ECCA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519064-18BA-1CDB-19AA-2A29554E3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188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287BDD-9463-3AED-548E-435A5322B0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4E64A2-3F6D-03EB-E76D-5046D5A6C0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43AA9C-110C-6439-5410-F3CF4C84BC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390388-7848-4138-531B-EF7F15E21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5C8E1D-B33D-C775-C3DB-16B67AF93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BB3E97-98B0-29A3-9A63-2EA4A8910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734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B1D7BD-CDAC-68DD-C607-2E71AB3D3F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BC608A-12FF-754B-AF73-6DDBDF80C9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5060F9-A318-F7D9-7F7A-431771AB91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A5AA70-A864-7D31-742F-E7BD4D0D15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91EC38-407C-52B9-1DA8-1E0EBDCB00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81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Table 12"/>
          <p:cNvGraphicFramePr>
            <a:graphicFrameLocks noGrp="1"/>
          </p:cNvGraphicFramePr>
          <p:nvPr/>
        </p:nvGraphicFramePr>
        <p:xfrm>
          <a:off x="370705" y="372283"/>
          <a:ext cx="11775985" cy="2162434"/>
        </p:xfrm>
        <a:graphic>
          <a:graphicData uri="http://schemas.openxmlformats.org/drawingml/2006/table">
            <a:tbl>
              <a:tblPr/>
              <a:tblGrid>
                <a:gridCol w="12347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803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2347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31186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31186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23471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131186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123471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123471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131186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  <a:gridCol w="123471">
                  <a:extLst>
                    <a:ext uri="{9D8B030D-6E8A-4147-A177-3AD203B41FA5}">
                      <a16:colId xmlns:a16="http://schemas.microsoft.com/office/drawing/2014/main" val="20021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22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23"/>
                    </a:ext>
                  </a:extLst>
                </a:gridCol>
                <a:gridCol w="131186">
                  <a:extLst>
                    <a:ext uri="{9D8B030D-6E8A-4147-A177-3AD203B41FA5}">
                      <a16:colId xmlns:a16="http://schemas.microsoft.com/office/drawing/2014/main" val="20024"/>
                    </a:ext>
                  </a:extLst>
                </a:gridCol>
                <a:gridCol w="154338">
                  <a:extLst>
                    <a:ext uri="{9D8B030D-6E8A-4147-A177-3AD203B41FA5}">
                      <a16:colId xmlns:a16="http://schemas.microsoft.com/office/drawing/2014/main" val="20025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26"/>
                    </a:ext>
                  </a:extLst>
                </a:gridCol>
                <a:gridCol w="154338">
                  <a:extLst>
                    <a:ext uri="{9D8B030D-6E8A-4147-A177-3AD203B41FA5}">
                      <a16:colId xmlns:a16="http://schemas.microsoft.com/office/drawing/2014/main" val="20027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28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29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0"/>
                    </a:ext>
                  </a:extLst>
                </a:gridCol>
                <a:gridCol w="162055">
                  <a:extLst>
                    <a:ext uri="{9D8B030D-6E8A-4147-A177-3AD203B41FA5}">
                      <a16:colId xmlns:a16="http://schemas.microsoft.com/office/drawing/2014/main" val="20031"/>
                    </a:ext>
                  </a:extLst>
                </a:gridCol>
                <a:gridCol w="156267">
                  <a:extLst>
                    <a:ext uri="{9D8B030D-6E8A-4147-A177-3AD203B41FA5}">
                      <a16:colId xmlns:a16="http://schemas.microsoft.com/office/drawing/2014/main" val="20032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3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4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35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6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37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38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9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40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41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42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43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44"/>
                    </a:ext>
                  </a:extLst>
                </a:gridCol>
                <a:gridCol w="154338">
                  <a:extLst>
                    <a:ext uri="{9D8B030D-6E8A-4147-A177-3AD203B41FA5}">
                      <a16:colId xmlns:a16="http://schemas.microsoft.com/office/drawing/2014/main" val="20045"/>
                    </a:ext>
                  </a:extLst>
                </a:gridCol>
                <a:gridCol w="131186">
                  <a:extLst>
                    <a:ext uri="{9D8B030D-6E8A-4147-A177-3AD203B41FA5}">
                      <a16:colId xmlns:a16="http://schemas.microsoft.com/office/drawing/2014/main" val="20046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47"/>
                    </a:ext>
                  </a:extLst>
                </a:gridCol>
                <a:gridCol w="131186">
                  <a:extLst>
                    <a:ext uri="{9D8B030D-6E8A-4147-A177-3AD203B41FA5}">
                      <a16:colId xmlns:a16="http://schemas.microsoft.com/office/drawing/2014/main" val="20048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49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50"/>
                    </a:ext>
                  </a:extLst>
                </a:gridCol>
                <a:gridCol w="131186">
                  <a:extLst>
                    <a:ext uri="{9D8B030D-6E8A-4147-A177-3AD203B41FA5}">
                      <a16:colId xmlns:a16="http://schemas.microsoft.com/office/drawing/2014/main" val="20051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52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53"/>
                    </a:ext>
                  </a:extLst>
                </a:gridCol>
                <a:gridCol w="156267">
                  <a:extLst>
                    <a:ext uri="{9D8B030D-6E8A-4147-A177-3AD203B41FA5}">
                      <a16:colId xmlns:a16="http://schemas.microsoft.com/office/drawing/2014/main" val="20054"/>
                    </a:ext>
                  </a:extLst>
                </a:gridCol>
                <a:gridCol w="123471">
                  <a:extLst>
                    <a:ext uri="{9D8B030D-6E8A-4147-A177-3AD203B41FA5}">
                      <a16:colId xmlns:a16="http://schemas.microsoft.com/office/drawing/2014/main" val="20055"/>
                    </a:ext>
                  </a:extLst>
                </a:gridCol>
                <a:gridCol w="108035">
                  <a:extLst>
                    <a:ext uri="{9D8B030D-6E8A-4147-A177-3AD203B41FA5}">
                      <a16:colId xmlns:a16="http://schemas.microsoft.com/office/drawing/2014/main" val="20056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57"/>
                    </a:ext>
                  </a:extLst>
                </a:gridCol>
                <a:gridCol w="123471">
                  <a:extLst>
                    <a:ext uri="{9D8B030D-6E8A-4147-A177-3AD203B41FA5}">
                      <a16:colId xmlns:a16="http://schemas.microsoft.com/office/drawing/2014/main" val="20058"/>
                    </a:ext>
                  </a:extLst>
                </a:gridCol>
                <a:gridCol w="123471">
                  <a:extLst>
                    <a:ext uri="{9D8B030D-6E8A-4147-A177-3AD203B41FA5}">
                      <a16:colId xmlns:a16="http://schemas.microsoft.com/office/drawing/2014/main" val="20059"/>
                    </a:ext>
                  </a:extLst>
                </a:gridCol>
                <a:gridCol w="123471">
                  <a:extLst>
                    <a:ext uri="{9D8B030D-6E8A-4147-A177-3AD203B41FA5}">
                      <a16:colId xmlns:a16="http://schemas.microsoft.com/office/drawing/2014/main" val="20060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61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62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63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64"/>
                    </a:ext>
                  </a:extLst>
                </a:gridCol>
                <a:gridCol w="123471">
                  <a:extLst>
                    <a:ext uri="{9D8B030D-6E8A-4147-A177-3AD203B41FA5}">
                      <a16:colId xmlns:a16="http://schemas.microsoft.com/office/drawing/2014/main" val="20065"/>
                    </a:ext>
                  </a:extLst>
                </a:gridCol>
                <a:gridCol w="131186">
                  <a:extLst>
                    <a:ext uri="{9D8B030D-6E8A-4147-A177-3AD203B41FA5}">
                      <a16:colId xmlns:a16="http://schemas.microsoft.com/office/drawing/2014/main" val="20066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67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68"/>
                    </a:ext>
                  </a:extLst>
                </a:gridCol>
                <a:gridCol w="123471">
                  <a:extLst>
                    <a:ext uri="{9D8B030D-6E8A-4147-A177-3AD203B41FA5}">
                      <a16:colId xmlns:a16="http://schemas.microsoft.com/office/drawing/2014/main" val="20069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70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71"/>
                    </a:ext>
                  </a:extLst>
                </a:gridCol>
                <a:gridCol w="123471">
                  <a:extLst>
                    <a:ext uri="{9D8B030D-6E8A-4147-A177-3AD203B41FA5}">
                      <a16:colId xmlns:a16="http://schemas.microsoft.com/office/drawing/2014/main" val="20072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73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74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75"/>
                    </a:ext>
                  </a:extLst>
                </a:gridCol>
                <a:gridCol w="108035">
                  <a:extLst>
                    <a:ext uri="{9D8B030D-6E8A-4147-A177-3AD203B41FA5}">
                      <a16:colId xmlns:a16="http://schemas.microsoft.com/office/drawing/2014/main" val="20076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77"/>
                    </a:ext>
                  </a:extLst>
                </a:gridCol>
                <a:gridCol w="131186">
                  <a:extLst>
                    <a:ext uri="{9D8B030D-6E8A-4147-A177-3AD203B41FA5}">
                      <a16:colId xmlns:a16="http://schemas.microsoft.com/office/drawing/2014/main" val="20078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79"/>
                    </a:ext>
                  </a:extLst>
                </a:gridCol>
                <a:gridCol w="108035">
                  <a:extLst>
                    <a:ext uri="{9D8B030D-6E8A-4147-A177-3AD203B41FA5}">
                      <a16:colId xmlns:a16="http://schemas.microsoft.com/office/drawing/2014/main" val="20080"/>
                    </a:ext>
                  </a:extLst>
                </a:gridCol>
                <a:gridCol w="108035">
                  <a:extLst>
                    <a:ext uri="{9D8B030D-6E8A-4147-A177-3AD203B41FA5}">
                      <a16:colId xmlns:a16="http://schemas.microsoft.com/office/drawing/2014/main" val="20081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82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83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84"/>
                    </a:ext>
                  </a:extLst>
                </a:gridCol>
                <a:gridCol w="123471">
                  <a:extLst>
                    <a:ext uri="{9D8B030D-6E8A-4147-A177-3AD203B41FA5}">
                      <a16:colId xmlns:a16="http://schemas.microsoft.com/office/drawing/2014/main" val="20085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86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87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88"/>
                    </a:ext>
                  </a:extLst>
                </a:gridCol>
                <a:gridCol w="131186">
                  <a:extLst>
                    <a:ext uri="{9D8B030D-6E8A-4147-A177-3AD203B41FA5}">
                      <a16:colId xmlns:a16="http://schemas.microsoft.com/office/drawing/2014/main" val="20089"/>
                    </a:ext>
                  </a:extLst>
                </a:gridCol>
                <a:gridCol w="131186">
                  <a:extLst>
                    <a:ext uri="{9D8B030D-6E8A-4147-A177-3AD203B41FA5}">
                      <a16:colId xmlns:a16="http://schemas.microsoft.com/office/drawing/2014/main" val="20090"/>
                    </a:ext>
                  </a:extLst>
                </a:gridCol>
              </a:tblGrid>
              <a:tr h="209008"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A1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B2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37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67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77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C7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38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58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68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C8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E8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DADD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0A6D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DA4D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CA4D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A2D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998D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295D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88C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81C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372C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3056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c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lk9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gt2b3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17a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grg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btb16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p2b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k32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mem18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p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gt2b1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ik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f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l2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nb1ip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l17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aca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cl9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pp1r17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mprss1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pgrip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ap1l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v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b21l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9008"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B0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C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D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62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72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92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D2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B3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64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64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B4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F4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F4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55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06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46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B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B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D6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E6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F6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0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0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17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17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27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47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67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97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97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97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B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C7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D7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D7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D7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E7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1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1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1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2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3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3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4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4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58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58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78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D3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0D2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FD2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D1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BD0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BD0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BCF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BCF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CF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CF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CF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CE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CE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CD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CD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CD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CD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CC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CC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CC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2CA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7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7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5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7C5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C3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F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BBE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ABD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9BD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9BD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9BD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8BC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4BA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9A2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89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98406"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sg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dh1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fb5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n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icd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l3st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x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ph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erg1l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glec10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36a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dn1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t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cer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nx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crl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x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s4a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c11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vcr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camr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pz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frsf13c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ll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cmr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lp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pln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180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m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od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e6h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ir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x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btb3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e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cl1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kap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n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ban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h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e6c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tn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5r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tnl9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cr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cr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nk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far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ox1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ah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b-bs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r7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eal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s7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6a19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qp7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amts1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p7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n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cr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dh4a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p4b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stamp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a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rc5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s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lr1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28a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46a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eg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pi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ca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gt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glech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p3a9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m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rriq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v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p4a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mprss11d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abp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dn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t2h2aa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st1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mp2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r17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px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p2c2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a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mp8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9008"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35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45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26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96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A6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A6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B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C6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D6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57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87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97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97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C7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094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8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06444"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o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of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krd36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5c1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amts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m67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as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rrm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wa5b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s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rrn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rt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ygo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c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msb15b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pph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qcg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75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14" name="Table 13"/>
          <p:cNvGraphicFramePr>
            <a:graphicFrameLocks noGrp="1"/>
          </p:cNvGraphicFramePr>
          <p:nvPr/>
        </p:nvGraphicFramePr>
        <p:xfrm>
          <a:off x="321012" y="2707454"/>
          <a:ext cx="11775985" cy="1980774"/>
        </p:xfrm>
        <a:graphic>
          <a:graphicData uri="http://schemas.openxmlformats.org/drawingml/2006/table">
            <a:tbl>
              <a:tblPr/>
              <a:tblGrid>
                <a:gridCol w="1234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803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21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22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23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24"/>
                    </a:ext>
                  </a:extLst>
                </a:gridCol>
                <a:gridCol w="154337">
                  <a:extLst>
                    <a:ext uri="{9D8B030D-6E8A-4147-A177-3AD203B41FA5}">
                      <a16:colId xmlns:a16="http://schemas.microsoft.com/office/drawing/2014/main" val="20025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26"/>
                    </a:ext>
                  </a:extLst>
                </a:gridCol>
                <a:gridCol w="154337">
                  <a:extLst>
                    <a:ext uri="{9D8B030D-6E8A-4147-A177-3AD203B41FA5}">
                      <a16:colId xmlns:a16="http://schemas.microsoft.com/office/drawing/2014/main" val="20027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28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29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0"/>
                    </a:ext>
                  </a:extLst>
                </a:gridCol>
                <a:gridCol w="162055">
                  <a:extLst>
                    <a:ext uri="{9D8B030D-6E8A-4147-A177-3AD203B41FA5}">
                      <a16:colId xmlns:a16="http://schemas.microsoft.com/office/drawing/2014/main" val="20031"/>
                    </a:ext>
                  </a:extLst>
                </a:gridCol>
                <a:gridCol w="156267">
                  <a:extLst>
                    <a:ext uri="{9D8B030D-6E8A-4147-A177-3AD203B41FA5}">
                      <a16:colId xmlns:a16="http://schemas.microsoft.com/office/drawing/2014/main" val="20032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3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4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35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6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37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38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9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40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41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42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43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44"/>
                    </a:ext>
                  </a:extLst>
                </a:gridCol>
                <a:gridCol w="154337">
                  <a:extLst>
                    <a:ext uri="{9D8B030D-6E8A-4147-A177-3AD203B41FA5}">
                      <a16:colId xmlns:a16="http://schemas.microsoft.com/office/drawing/2014/main" val="20045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46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47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48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49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50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51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52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53"/>
                    </a:ext>
                  </a:extLst>
                </a:gridCol>
                <a:gridCol w="156267">
                  <a:extLst>
                    <a:ext uri="{9D8B030D-6E8A-4147-A177-3AD203B41FA5}">
                      <a16:colId xmlns:a16="http://schemas.microsoft.com/office/drawing/2014/main" val="20054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55"/>
                    </a:ext>
                  </a:extLst>
                </a:gridCol>
                <a:gridCol w="108036">
                  <a:extLst>
                    <a:ext uri="{9D8B030D-6E8A-4147-A177-3AD203B41FA5}">
                      <a16:colId xmlns:a16="http://schemas.microsoft.com/office/drawing/2014/main" val="20056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57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58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59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60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61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62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63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64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65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66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67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68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69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70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71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72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73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74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75"/>
                    </a:ext>
                  </a:extLst>
                </a:gridCol>
                <a:gridCol w="108036">
                  <a:extLst>
                    <a:ext uri="{9D8B030D-6E8A-4147-A177-3AD203B41FA5}">
                      <a16:colId xmlns:a16="http://schemas.microsoft.com/office/drawing/2014/main" val="20076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77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78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79"/>
                    </a:ext>
                  </a:extLst>
                </a:gridCol>
                <a:gridCol w="108036">
                  <a:extLst>
                    <a:ext uri="{9D8B030D-6E8A-4147-A177-3AD203B41FA5}">
                      <a16:colId xmlns:a16="http://schemas.microsoft.com/office/drawing/2014/main" val="20080"/>
                    </a:ext>
                  </a:extLst>
                </a:gridCol>
                <a:gridCol w="108036">
                  <a:extLst>
                    <a:ext uri="{9D8B030D-6E8A-4147-A177-3AD203B41FA5}">
                      <a16:colId xmlns:a16="http://schemas.microsoft.com/office/drawing/2014/main" val="20081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82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83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84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85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86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87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88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89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90"/>
                    </a:ext>
                  </a:extLst>
                </a:gridCol>
              </a:tblGrid>
              <a:tr h="201173">
                <a:tc>
                  <a:txBody>
                    <a:bodyPr/>
                    <a:lstStyle/>
                    <a:p>
                      <a:pPr algn="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94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C4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F4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87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18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472C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371C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271C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48769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c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est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mtm2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dc15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bn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lk9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po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h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kt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7a10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p6v1c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1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1173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2A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BA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D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FA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1B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6B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AB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B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CA3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9A2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8A1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A0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998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798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64243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atl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glec8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38a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ad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dhb8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cpt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dn8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lp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cpt1l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nn1g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dhb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2bc1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p2d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t2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erg1l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a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d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1173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F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73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B3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14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A4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65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E5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26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36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E6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17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87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183C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47B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64243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xc10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a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bx6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qp8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x38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an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g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nq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in2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m229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ql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tll1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7a1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r0b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h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r17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zmc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15" name="Table 14"/>
          <p:cNvGraphicFramePr>
            <a:graphicFrameLocks noGrp="1"/>
          </p:cNvGraphicFramePr>
          <p:nvPr/>
        </p:nvGraphicFramePr>
        <p:xfrm>
          <a:off x="321011" y="4782320"/>
          <a:ext cx="11775986" cy="2087440"/>
        </p:xfrm>
        <a:graphic>
          <a:graphicData uri="http://schemas.openxmlformats.org/drawingml/2006/table">
            <a:tbl>
              <a:tblPr/>
              <a:tblGrid>
                <a:gridCol w="1234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803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21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22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23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24"/>
                    </a:ext>
                  </a:extLst>
                </a:gridCol>
                <a:gridCol w="154337">
                  <a:extLst>
                    <a:ext uri="{9D8B030D-6E8A-4147-A177-3AD203B41FA5}">
                      <a16:colId xmlns:a16="http://schemas.microsoft.com/office/drawing/2014/main" val="20025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26"/>
                    </a:ext>
                  </a:extLst>
                </a:gridCol>
                <a:gridCol w="154337">
                  <a:extLst>
                    <a:ext uri="{9D8B030D-6E8A-4147-A177-3AD203B41FA5}">
                      <a16:colId xmlns:a16="http://schemas.microsoft.com/office/drawing/2014/main" val="20027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28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29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0"/>
                    </a:ext>
                  </a:extLst>
                </a:gridCol>
                <a:gridCol w="162056">
                  <a:extLst>
                    <a:ext uri="{9D8B030D-6E8A-4147-A177-3AD203B41FA5}">
                      <a16:colId xmlns:a16="http://schemas.microsoft.com/office/drawing/2014/main" val="20031"/>
                    </a:ext>
                  </a:extLst>
                </a:gridCol>
                <a:gridCol w="156267">
                  <a:extLst>
                    <a:ext uri="{9D8B030D-6E8A-4147-A177-3AD203B41FA5}">
                      <a16:colId xmlns:a16="http://schemas.microsoft.com/office/drawing/2014/main" val="20032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3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4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35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6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37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38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39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40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41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42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43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44"/>
                    </a:ext>
                  </a:extLst>
                </a:gridCol>
                <a:gridCol w="154337">
                  <a:extLst>
                    <a:ext uri="{9D8B030D-6E8A-4147-A177-3AD203B41FA5}">
                      <a16:colId xmlns:a16="http://schemas.microsoft.com/office/drawing/2014/main" val="20045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46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47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48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49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50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51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52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53"/>
                    </a:ext>
                  </a:extLst>
                </a:gridCol>
                <a:gridCol w="156267">
                  <a:extLst>
                    <a:ext uri="{9D8B030D-6E8A-4147-A177-3AD203B41FA5}">
                      <a16:colId xmlns:a16="http://schemas.microsoft.com/office/drawing/2014/main" val="20054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55"/>
                    </a:ext>
                  </a:extLst>
                </a:gridCol>
                <a:gridCol w="108036">
                  <a:extLst>
                    <a:ext uri="{9D8B030D-6E8A-4147-A177-3AD203B41FA5}">
                      <a16:colId xmlns:a16="http://schemas.microsoft.com/office/drawing/2014/main" val="20056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57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58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59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60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61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62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63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64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65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66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67"/>
                    </a:ext>
                  </a:extLst>
                </a:gridCol>
                <a:gridCol w="138904">
                  <a:extLst>
                    <a:ext uri="{9D8B030D-6E8A-4147-A177-3AD203B41FA5}">
                      <a16:colId xmlns:a16="http://schemas.microsoft.com/office/drawing/2014/main" val="20068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69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70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71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72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73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74"/>
                    </a:ext>
                  </a:extLst>
                </a:gridCol>
                <a:gridCol w="133117">
                  <a:extLst>
                    <a:ext uri="{9D8B030D-6E8A-4147-A177-3AD203B41FA5}">
                      <a16:colId xmlns:a16="http://schemas.microsoft.com/office/drawing/2014/main" val="20075"/>
                    </a:ext>
                  </a:extLst>
                </a:gridCol>
                <a:gridCol w="108036">
                  <a:extLst>
                    <a:ext uri="{9D8B030D-6E8A-4147-A177-3AD203B41FA5}">
                      <a16:colId xmlns:a16="http://schemas.microsoft.com/office/drawing/2014/main" val="20076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77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78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79"/>
                    </a:ext>
                  </a:extLst>
                </a:gridCol>
                <a:gridCol w="108036">
                  <a:extLst>
                    <a:ext uri="{9D8B030D-6E8A-4147-A177-3AD203B41FA5}">
                      <a16:colId xmlns:a16="http://schemas.microsoft.com/office/drawing/2014/main" val="20080"/>
                    </a:ext>
                  </a:extLst>
                </a:gridCol>
                <a:gridCol w="108036">
                  <a:extLst>
                    <a:ext uri="{9D8B030D-6E8A-4147-A177-3AD203B41FA5}">
                      <a16:colId xmlns:a16="http://schemas.microsoft.com/office/drawing/2014/main" val="20081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82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83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84"/>
                    </a:ext>
                  </a:extLst>
                </a:gridCol>
                <a:gridCol w="123470">
                  <a:extLst>
                    <a:ext uri="{9D8B030D-6E8A-4147-A177-3AD203B41FA5}">
                      <a16:colId xmlns:a16="http://schemas.microsoft.com/office/drawing/2014/main" val="20085"/>
                    </a:ext>
                  </a:extLst>
                </a:gridCol>
                <a:gridCol w="109966">
                  <a:extLst>
                    <a:ext uri="{9D8B030D-6E8A-4147-A177-3AD203B41FA5}">
                      <a16:colId xmlns:a16="http://schemas.microsoft.com/office/drawing/2014/main" val="20086"/>
                    </a:ext>
                  </a:extLst>
                </a:gridCol>
                <a:gridCol w="115754">
                  <a:extLst>
                    <a:ext uri="{9D8B030D-6E8A-4147-A177-3AD203B41FA5}">
                      <a16:colId xmlns:a16="http://schemas.microsoft.com/office/drawing/2014/main" val="20087"/>
                    </a:ext>
                  </a:extLst>
                </a:gridCol>
                <a:gridCol w="146621">
                  <a:extLst>
                    <a:ext uri="{9D8B030D-6E8A-4147-A177-3AD203B41FA5}">
                      <a16:colId xmlns:a16="http://schemas.microsoft.com/office/drawing/2014/main" val="20088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89"/>
                    </a:ext>
                  </a:extLst>
                </a:gridCol>
                <a:gridCol w="131187">
                  <a:extLst>
                    <a:ext uri="{9D8B030D-6E8A-4147-A177-3AD203B41FA5}">
                      <a16:colId xmlns:a16="http://schemas.microsoft.com/office/drawing/2014/main" val="20090"/>
                    </a:ext>
                  </a:extLst>
                </a:gridCol>
              </a:tblGrid>
              <a:tr h="207151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01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55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56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76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B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B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78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A8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E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3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3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3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49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4BA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4BA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1B8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1B8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EB6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DB6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B5D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B5D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B4D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8B3D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6B2D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4B1D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4B1D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B0D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AE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AB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8AA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AA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A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A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A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2A7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0A6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0A6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A0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A0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59F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39E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39E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29E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29E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B9A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697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596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E9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88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87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80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B76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975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673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78039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tnl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tnlb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fb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tih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bf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btb16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m1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rrc7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m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nar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glec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as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16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bxo40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gptl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00a9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far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h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bs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69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eb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hl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dh1b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egf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l2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s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isa8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migd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j1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gs16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le6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tv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v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9a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a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mynd1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gr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frsf12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ted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nd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py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rrn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6a1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dh1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sx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r4a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axin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p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ln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n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pc1l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bp6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dnf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vx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ch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n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sb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7151"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70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A1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CD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CC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3CB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2CB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2CB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0CAE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7C5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C2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2B9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EB6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DAD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19D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46171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pl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16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pal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stm2b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pnpep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ucy2g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slg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10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t2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13a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c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bbr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cn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sad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lrp10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b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7151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81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91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92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CAC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AB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8AA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2A7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EA4D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9A2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59F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29ED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295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18B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8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B7FC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67CC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41777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ox15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c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bx4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t8f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t2h2aa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kg7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cl9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zmm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lmd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rtr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sk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ipoq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12rb2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p2b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id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zma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hfe1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3</a:t>
                      </a: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9" marR="5189" marT="518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4406401" y="418596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406401" y="289585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20" name="Rectangle 19"/>
          <p:cNvSpPr/>
          <p:nvPr/>
        </p:nvSpPr>
        <p:spPr>
          <a:xfrm>
            <a:off x="0" y="217410"/>
            <a:ext cx="12179643" cy="2317307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-36800" y="28879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d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-36800" y="104242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-86493" y="178239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4d</a:t>
            </a:r>
          </a:p>
        </p:txBody>
      </p:sp>
      <p:sp>
        <p:nvSpPr>
          <p:cNvPr id="24" name="Rectangle 23"/>
          <p:cNvSpPr/>
          <p:nvPr/>
        </p:nvSpPr>
        <p:spPr>
          <a:xfrm>
            <a:off x="0" y="2506308"/>
            <a:ext cx="12179643" cy="2166127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/>
          <p:cNvSpPr txBox="1"/>
          <p:nvPr/>
        </p:nvSpPr>
        <p:spPr>
          <a:xfrm>
            <a:off x="-36800" y="260610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d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-36800" y="327184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-86493" y="3937586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4d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4406401" y="5925561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29" name="Rectangle 28"/>
          <p:cNvSpPr/>
          <p:nvPr/>
        </p:nvSpPr>
        <p:spPr>
          <a:xfrm>
            <a:off x="12357" y="4702806"/>
            <a:ext cx="12179643" cy="2166127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/>
          <p:cNvSpPr txBox="1"/>
          <p:nvPr/>
        </p:nvSpPr>
        <p:spPr>
          <a:xfrm>
            <a:off x="-36800" y="475684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d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-36800" y="551048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-86493" y="6110227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4d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-86493" y="-87828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85455" y="368590"/>
            <a:ext cx="4977711" cy="288012"/>
          </a:xfrm>
          <a:prstGeom prst="rect">
            <a:avLst/>
          </a:prstGeom>
        </p:spPr>
      </p:pic>
      <p:sp>
        <p:nvSpPr>
          <p:cNvPr id="35" name="TextBox 34"/>
          <p:cNvSpPr txBox="1"/>
          <p:nvPr/>
        </p:nvSpPr>
        <p:spPr>
          <a:xfrm>
            <a:off x="9162536" y="69024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og FC</a:t>
            </a:r>
          </a:p>
        </p:txBody>
      </p:sp>
    </p:spTree>
    <p:extLst>
      <p:ext uri="{BB962C8B-B14F-4D97-AF65-F5344CB8AC3E}">
        <p14:creationId xmlns:p14="http://schemas.microsoft.com/office/powerpoint/2010/main" val="3779971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95</Words>
  <Application>Microsoft Office PowerPoint</Application>
  <PresentationFormat>Widescreen</PresentationFormat>
  <Paragraphs>28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>Rush University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ghan Moran</dc:creator>
  <cp:lastModifiedBy>Meghan Moran</cp:lastModifiedBy>
  <cp:revision>14</cp:revision>
  <dcterms:created xsi:type="dcterms:W3CDTF">2025-11-21T17:16:35Z</dcterms:created>
  <dcterms:modified xsi:type="dcterms:W3CDTF">2025-11-21T17:28:33Z</dcterms:modified>
</cp:coreProperties>
</file>